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12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B1F0-D38C-4865-8C8F-F42D49FFB998}" type="datetimeFigureOut">
              <a:rPr lang="en-GB" smtClean="0"/>
              <a:t>10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49B5B-498F-45B5-9E5D-3BFFD91AD7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4774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B1F0-D38C-4865-8C8F-F42D49FFB998}" type="datetimeFigureOut">
              <a:rPr lang="en-GB" smtClean="0"/>
              <a:t>10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49B5B-498F-45B5-9E5D-3BFFD91AD7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7680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B1F0-D38C-4865-8C8F-F42D49FFB998}" type="datetimeFigureOut">
              <a:rPr lang="en-GB" smtClean="0"/>
              <a:t>10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49B5B-498F-45B5-9E5D-3BFFD91AD7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5938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B1F0-D38C-4865-8C8F-F42D49FFB998}" type="datetimeFigureOut">
              <a:rPr lang="en-GB" smtClean="0"/>
              <a:t>10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49B5B-498F-45B5-9E5D-3BFFD91AD7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7578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B1F0-D38C-4865-8C8F-F42D49FFB998}" type="datetimeFigureOut">
              <a:rPr lang="en-GB" smtClean="0"/>
              <a:t>10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49B5B-498F-45B5-9E5D-3BFFD91AD7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9348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B1F0-D38C-4865-8C8F-F42D49FFB998}" type="datetimeFigureOut">
              <a:rPr lang="en-GB" smtClean="0"/>
              <a:t>10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49B5B-498F-45B5-9E5D-3BFFD91AD7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80375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B1F0-D38C-4865-8C8F-F42D49FFB998}" type="datetimeFigureOut">
              <a:rPr lang="en-GB" smtClean="0"/>
              <a:t>10/04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49B5B-498F-45B5-9E5D-3BFFD91AD7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2079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B1F0-D38C-4865-8C8F-F42D49FFB998}" type="datetimeFigureOut">
              <a:rPr lang="en-GB" smtClean="0"/>
              <a:t>10/04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49B5B-498F-45B5-9E5D-3BFFD91AD7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9604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B1F0-D38C-4865-8C8F-F42D49FFB998}" type="datetimeFigureOut">
              <a:rPr lang="en-GB" smtClean="0"/>
              <a:t>10/04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49B5B-498F-45B5-9E5D-3BFFD91AD7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3246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B1F0-D38C-4865-8C8F-F42D49FFB998}" type="datetimeFigureOut">
              <a:rPr lang="en-GB" smtClean="0"/>
              <a:t>10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49B5B-498F-45B5-9E5D-3BFFD91AD7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7082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B1F0-D38C-4865-8C8F-F42D49FFB998}" type="datetimeFigureOut">
              <a:rPr lang="en-GB" smtClean="0"/>
              <a:t>10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49B5B-498F-45B5-9E5D-3BFFD91AD7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7621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3B1F0-D38C-4865-8C8F-F42D49FFB998}" type="datetimeFigureOut">
              <a:rPr lang="en-GB" smtClean="0"/>
              <a:t>10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E49B5B-498F-45B5-9E5D-3BFFD91AD7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1648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4153" y="594616"/>
            <a:ext cx="5815951" cy="2021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4152" y="2846968"/>
            <a:ext cx="5815951" cy="17343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4152" y="4812654"/>
            <a:ext cx="5815951" cy="1447667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4152" y="6491673"/>
            <a:ext cx="5815951" cy="3597667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1" name="TextBox 10"/>
          <p:cNvSpPr txBox="1"/>
          <p:nvPr/>
        </p:nvSpPr>
        <p:spPr>
          <a:xfrm>
            <a:off x="484152" y="10766323"/>
            <a:ext cx="581595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–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o by two tables with sensitivities, specificities and their 95% confidence intervals. 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9252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</TotalTime>
  <Words>1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 G</dc:creator>
  <cp:lastModifiedBy>Oghenekome Gbinigie</cp:lastModifiedBy>
  <cp:revision>3</cp:revision>
  <dcterms:created xsi:type="dcterms:W3CDTF">2018-12-16T11:26:22Z</dcterms:created>
  <dcterms:modified xsi:type="dcterms:W3CDTF">2019-04-10T14:32:59Z</dcterms:modified>
</cp:coreProperties>
</file>